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19A6048-C6DC-4DA3-A424-2DC178FBC488}" v="27" dt="2021-03-23T10:26:56.90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34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na Alexander" userId="6b791bb9-1e72-4323-b8cd-e886e48204de" providerId="ADAL" clId="{F19A6048-C6DC-4DA3-A424-2DC178FBC488}"/>
    <pc:docChg chg="undo custSel addSld modSld">
      <pc:chgData name="Marina Alexander" userId="6b791bb9-1e72-4323-b8cd-e886e48204de" providerId="ADAL" clId="{F19A6048-C6DC-4DA3-A424-2DC178FBC488}" dt="2021-03-23T10:26:56.909" v="753" actId="164"/>
      <pc:docMkLst>
        <pc:docMk/>
      </pc:docMkLst>
      <pc:sldChg chg="addSp delSp modSp mod">
        <pc:chgData name="Marina Alexander" userId="6b791bb9-1e72-4323-b8cd-e886e48204de" providerId="ADAL" clId="{F19A6048-C6DC-4DA3-A424-2DC178FBC488}" dt="2021-03-23T10:09:42.850" v="426" actId="1076"/>
        <pc:sldMkLst>
          <pc:docMk/>
          <pc:sldMk cId="2854714784" sldId="256"/>
        </pc:sldMkLst>
        <pc:spChg chg="del mod">
          <ac:chgData name="Marina Alexander" userId="6b791bb9-1e72-4323-b8cd-e886e48204de" providerId="ADAL" clId="{F19A6048-C6DC-4DA3-A424-2DC178FBC488}" dt="2021-03-23T10:09:25.843" v="423" actId="478"/>
          <ac:spMkLst>
            <pc:docMk/>
            <pc:sldMk cId="2854714784" sldId="256"/>
            <ac:spMk id="4" creationId="{0A1CBD60-087F-42BD-8313-98CD138298F2}"/>
          </ac:spMkLst>
        </pc:spChg>
        <pc:spChg chg="mod">
          <ac:chgData name="Marina Alexander" userId="6b791bb9-1e72-4323-b8cd-e886e48204de" providerId="ADAL" clId="{F19A6048-C6DC-4DA3-A424-2DC178FBC488}" dt="2021-03-23T10:09:35.898" v="425" actId="1076"/>
          <ac:spMkLst>
            <pc:docMk/>
            <pc:sldMk cId="2854714784" sldId="256"/>
            <ac:spMk id="11" creationId="{E66B9806-EB91-4C61-BB8C-255CC1769362}"/>
          </ac:spMkLst>
        </pc:spChg>
        <pc:spChg chg="add mod">
          <ac:chgData name="Marina Alexander" userId="6b791bb9-1e72-4323-b8cd-e886e48204de" providerId="ADAL" clId="{F19A6048-C6DC-4DA3-A424-2DC178FBC488}" dt="2021-03-23T10:09:42.850" v="426" actId="1076"/>
          <ac:spMkLst>
            <pc:docMk/>
            <pc:sldMk cId="2854714784" sldId="256"/>
            <ac:spMk id="12" creationId="{228E403D-43AF-4B33-94ED-C0362921D2DE}"/>
          </ac:spMkLst>
        </pc:spChg>
        <pc:spChg chg="add del mod">
          <ac:chgData name="Marina Alexander" userId="6b791bb9-1e72-4323-b8cd-e886e48204de" providerId="ADAL" clId="{F19A6048-C6DC-4DA3-A424-2DC178FBC488}" dt="2021-03-23T10:09:25.843" v="423" actId="478"/>
          <ac:spMkLst>
            <pc:docMk/>
            <pc:sldMk cId="2854714784" sldId="256"/>
            <ac:spMk id="14" creationId="{F04765F5-1808-4F5F-A65E-0D334867AD5E}"/>
          </ac:spMkLst>
        </pc:spChg>
        <pc:graphicFrameChg chg="add mod modGraphic">
          <ac:chgData name="Marina Alexander" userId="6b791bb9-1e72-4323-b8cd-e886e48204de" providerId="ADAL" clId="{F19A6048-C6DC-4DA3-A424-2DC178FBC488}" dt="2021-03-23T10:09:42.850" v="426" actId="1076"/>
          <ac:graphicFrameMkLst>
            <pc:docMk/>
            <pc:sldMk cId="2854714784" sldId="256"/>
            <ac:graphicFrameMk id="13" creationId="{144B02AC-EE7D-43BC-AC46-91CCBCDA97A3}"/>
          </ac:graphicFrameMkLst>
        </pc:graphicFrameChg>
        <pc:graphicFrameChg chg="add del modGraphic">
          <ac:chgData name="Marina Alexander" userId="6b791bb9-1e72-4323-b8cd-e886e48204de" providerId="ADAL" clId="{F19A6048-C6DC-4DA3-A424-2DC178FBC488}" dt="2021-03-23T10:09:23.507" v="422" actId="27309"/>
          <ac:graphicFrameMkLst>
            <pc:docMk/>
            <pc:sldMk cId="2854714784" sldId="256"/>
            <ac:graphicFrameMk id="16" creationId="{7CFAF340-504B-4F79-9E39-2B567935B782}"/>
          </ac:graphicFrameMkLst>
        </pc:graphicFrameChg>
        <pc:picChg chg="del mod">
          <ac:chgData name="Marina Alexander" userId="6b791bb9-1e72-4323-b8cd-e886e48204de" providerId="ADAL" clId="{F19A6048-C6DC-4DA3-A424-2DC178FBC488}" dt="2021-03-23T10:09:25.843" v="423" actId="478"/>
          <ac:picMkLst>
            <pc:docMk/>
            <pc:sldMk cId="2854714784" sldId="256"/>
            <ac:picMk id="6" creationId="{5C9750D7-8944-4B3A-80B3-EC8148264ED8}"/>
          </ac:picMkLst>
        </pc:picChg>
        <pc:picChg chg="del mod">
          <ac:chgData name="Marina Alexander" userId="6b791bb9-1e72-4323-b8cd-e886e48204de" providerId="ADAL" clId="{F19A6048-C6DC-4DA3-A424-2DC178FBC488}" dt="2021-03-23T10:09:25.843" v="423" actId="478"/>
          <ac:picMkLst>
            <pc:docMk/>
            <pc:sldMk cId="2854714784" sldId="256"/>
            <ac:picMk id="8" creationId="{840B1893-8504-4072-9B64-731FEA1FCB98}"/>
          </ac:picMkLst>
        </pc:picChg>
        <pc:picChg chg="mod">
          <ac:chgData name="Marina Alexander" userId="6b791bb9-1e72-4323-b8cd-e886e48204de" providerId="ADAL" clId="{F19A6048-C6DC-4DA3-A424-2DC178FBC488}" dt="2021-03-23T10:09:35.898" v="425" actId="1076"/>
          <ac:picMkLst>
            <pc:docMk/>
            <pc:sldMk cId="2854714784" sldId="256"/>
            <ac:picMk id="10" creationId="{0EB8C133-AC58-4709-9941-0D0341CBE276}"/>
          </ac:picMkLst>
        </pc:picChg>
      </pc:sldChg>
      <pc:sldChg chg="addSp delSp modSp new mod">
        <pc:chgData name="Marina Alexander" userId="6b791bb9-1e72-4323-b8cd-e886e48204de" providerId="ADAL" clId="{F19A6048-C6DC-4DA3-A424-2DC178FBC488}" dt="2021-03-23T10:26:56.909" v="753" actId="164"/>
        <pc:sldMkLst>
          <pc:docMk/>
          <pc:sldMk cId="2484346042" sldId="257"/>
        </pc:sldMkLst>
        <pc:spChg chg="del">
          <ac:chgData name="Marina Alexander" userId="6b791bb9-1e72-4323-b8cd-e886e48204de" providerId="ADAL" clId="{F19A6048-C6DC-4DA3-A424-2DC178FBC488}" dt="2021-03-23T10:09:48.074" v="427" actId="478"/>
          <ac:spMkLst>
            <pc:docMk/>
            <pc:sldMk cId="2484346042" sldId="257"/>
            <ac:spMk id="2" creationId="{E7E2E523-4CD4-41D5-9788-587A1AE08886}"/>
          </ac:spMkLst>
        </pc:spChg>
        <pc:spChg chg="del">
          <ac:chgData name="Marina Alexander" userId="6b791bb9-1e72-4323-b8cd-e886e48204de" providerId="ADAL" clId="{F19A6048-C6DC-4DA3-A424-2DC178FBC488}" dt="2021-03-23T10:09:49.259" v="428" actId="478"/>
          <ac:spMkLst>
            <pc:docMk/>
            <pc:sldMk cId="2484346042" sldId="257"/>
            <ac:spMk id="3" creationId="{D8283F45-D011-4236-9DC6-64319C095FFB}"/>
          </ac:spMkLst>
        </pc:spChg>
        <pc:spChg chg="add mod">
          <ac:chgData name="Marina Alexander" userId="6b791bb9-1e72-4323-b8cd-e886e48204de" providerId="ADAL" clId="{F19A6048-C6DC-4DA3-A424-2DC178FBC488}" dt="2021-03-23T10:09:59.137" v="430" actId="1076"/>
          <ac:spMkLst>
            <pc:docMk/>
            <pc:sldMk cId="2484346042" sldId="257"/>
            <ac:spMk id="4" creationId="{A98F2DA8-9C94-4025-A97B-BFFA128AD58F}"/>
          </ac:spMkLst>
        </pc:spChg>
        <pc:spChg chg="add mod">
          <ac:chgData name="Marina Alexander" userId="6b791bb9-1e72-4323-b8cd-e886e48204de" providerId="ADAL" clId="{F19A6048-C6DC-4DA3-A424-2DC178FBC488}" dt="2021-03-23T10:26:10.956" v="725" actId="20577"/>
          <ac:spMkLst>
            <pc:docMk/>
            <pc:sldMk cId="2484346042" sldId="257"/>
            <ac:spMk id="7" creationId="{E746A199-474B-460F-B1B0-D396A4740A55}"/>
          </ac:spMkLst>
        </pc:spChg>
        <pc:spChg chg="add mod topLvl">
          <ac:chgData name="Marina Alexander" userId="6b791bb9-1e72-4323-b8cd-e886e48204de" providerId="ADAL" clId="{F19A6048-C6DC-4DA3-A424-2DC178FBC488}" dt="2021-03-23T10:26:56.909" v="753" actId="164"/>
          <ac:spMkLst>
            <pc:docMk/>
            <pc:sldMk cId="2484346042" sldId="257"/>
            <ac:spMk id="10" creationId="{08EC30F2-279C-49D4-9BB9-B436A16F00C2}"/>
          </ac:spMkLst>
        </pc:spChg>
        <pc:grpChg chg="add del mod">
          <ac:chgData name="Marina Alexander" userId="6b791bb9-1e72-4323-b8cd-e886e48204de" providerId="ADAL" clId="{F19A6048-C6DC-4DA3-A424-2DC178FBC488}" dt="2021-03-23T10:26:44.207" v="750" actId="165"/>
          <ac:grpSpMkLst>
            <pc:docMk/>
            <pc:sldMk cId="2484346042" sldId="257"/>
            <ac:grpSpMk id="11" creationId="{6FDA75D1-D526-4CAC-884B-40D7332A53F9}"/>
          </ac:grpSpMkLst>
        </pc:grpChg>
        <pc:grpChg chg="add mod">
          <ac:chgData name="Marina Alexander" userId="6b791bb9-1e72-4323-b8cd-e886e48204de" providerId="ADAL" clId="{F19A6048-C6DC-4DA3-A424-2DC178FBC488}" dt="2021-03-23T10:26:56.909" v="753" actId="164"/>
          <ac:grpSpMkLst>
            <pc:docMk/>
            <pc:sldMk cId="2484346042" sldId="257"/>
            <ac:grpSpMk id="12" creationId="{F527C90A-0673-46E7-B589-28F72D2CCFD8}"/>
          </ac:grpSpMkLst>
        </pc:grpChg>
        <pc:picChg chg="add mod">
          <ac:chgData name="Marina Alexander" userId="6b791bb9-1e72-4323-b8cd-e886e48204de" providerId="ADAL" clId="{F19A6048-C6DC-4DA3-A424-2DC178FBC488}" dt="2021-03-23T10:09:59.137" v="430" actId="1076"/>
          <ac:picMkLst>
            <pc:docMk/>
            <pc:sldMk cId="2484346042" sldId="257"/>
            <ac:picMk id="5" creationId="{156CA433-27EA-4A65-A16F-AE7227BB3DB1}"/>
          </ac:picMkLst>
        </pc:picChg>
        <pc:picChg chg="add mod">
          <ac:chgData name="Marina Alexander" userId="6b791bb9-1e72-4323-b8cd-e886e48204de" providerId="ADAL" clId="{F19A6048-C6DC-4DA3-A424-2DC178FBC488}" dt="2021-03-23T10:09:59.137" v="430" actId="1076"/>
          <ac:picMkLst>
            <pc:docMk/>
            <pc:sldMk cId="2484346042" sldId="257"/>
            <ac:picMk id="6" creationId="{1F706E25-1D7E-4B69-88F7-F217C30BC63F}"/>
          </ac:picMkLst>
        </pc:picChg>
        <pc:picChg chg="add mod topLvl">
          <ac:chgData name="Marina Alexander" userId="6b791bb9-1e72-4323-b8cd-e886e48204de" providerId="ADAL" clId="{F19A6048-C6DC-4DA3-A424-2DC178FBC488}" dt="2021-03-23T10:26:56.909" v="753" actId="164"/>
          <ac:picMkLst>
            <pc:docMk/>
            <pc:sldMk cId="2484346042" sldId="257"/>
            <ac:picMk id="9" creationId="{57D96330-D95F-4BFE-91F3-C0F9E6C92CB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3012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69066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8954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5559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4967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7329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8872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7874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097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933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5389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78C48-592B-4CA6-A21E-2CA3BBB31785}" type="datetimeFigureOut">
              <a:rPr lang="en-AU" smtClean="0"/>
              <a:t>1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512F6-FEA7-4012-8BAF-5F8AED721D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0215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picture containing diagram&#10;&#10;Description automatically generated">
            <a:extLst>
              <a:ext uri="{FF2B5EF4-FFF2-40B4-BE49-F238E27FC236}">
                <a16:creationId xmlns:a16="http://schemas.microsoft.com/office/drawing/2014/main" id="{0EB8C133-AC58-4709-9941-0D0341CBE27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6"/>
          <a:stretch/>
        </p:blipFill>
        <p:spPr>
          <a:xfrm>
            <a:off x="1468350" y="676841"/>
            <a:ext cx="4092484" cy="179832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66B9806-EB91-4C61-BB8C-255CC1769362}"/>
              </a:ext>
            </a:extLst>
          </p:cNvPr>
          <p:cNvSpPr txBox="1"/>
          <p:nvPr/>
        </p:nvSpPr>
        <p:spPr>
          <a:xfrm>
            <a:off x="1393745" y="2356001"/>
            <a:ext cx="43214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0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mage of TBE polyacrylamide gel for size selection of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NAse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digested RNA showing sections cut out (red) for further purification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8E403D-43AF-4B33-94ED-C0362921D2DE}"/>
              </a:ext>
            </a:extLst>
          </p:cNvPr>
          <p:cNvSpPr txBox="1"/>
          <p:nvPr/>
        </p:nvSpPr>
        <p:spPr>
          <a:xfrm>
            <a:off x="1015049" y="7498829"/>
            <a:ext cx="48862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2: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eads obtained for samples used in this analysis  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Table 13">
            <a:extLst>
              <a:ext uri="{FF2B5EF4-FFF2-40B4-BE49-F238E27FC236}">
                <a16:creationId xmlns:a16="http://schemas.microsoft.com/office/drawing/2014/main" id="{144B02AC-EE7D-43BC-AC46-91CCBCDA97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6961658"/>
              </p:ext>
            </p:extLst>
          </p:nvPr>
        </p:nvGraphicFramePr>
        <p:xfrm>
          <a:off x="1092200" y="4284473"/>
          <a:ext cx="4809066" cy="31699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03022">
                  <a:extLst>
                    <a:ext uri="{9D8B030D-6E8A-4147-A177-3AD203B41FA5}">
                      <a16:colId xmlns:a16="http://schemas.microsoft.com/office/drawing/2014/main" val="1082956217"/>
                    </a:ext>
                  </a:extLst>
                </a:gridCol>
                <a:gridCol w="1603022">
                  <a:extLst>
                    <a:ext uri="{9D8B030D-6E8A-4147-A177-3AD203B41FA5}">
                      <a16:colId xmlns:a16="http://schemas.microsoft.com/office/drawing/2014/main" val="1164813610"/>
                    </a:ext>
                  </a:extLst>
                </a:gridCol>
                <a:gridCol w="1603022">
                  <a:extLst>
                    <a:ext uri="{9D8B030D-6E8A-4147-A177-3AD203B41FA5}">
                      <a16:colId xmlns:a16="http://schemas.microsoft.com/office/drawing/2014/main" val="2565485740"/>
                    </a:ext>
                  </a:extLst>
                </a:gridCol>
              </a:tblGrid>
              <a:tr h="187601">
                <a:tc>
                  <a:txBody>
                    <a:bodyPr/>
                    <a:lstStyle/>
                    <a:p>
                      <a:r>
                        <a:rPr lang="en-AU" sz="1000" dirty="0"/>
                        <a:t>samp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/>
                        <a:t>protoc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/>
                        <a:t>rea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5298192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3,943,630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5662707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6,038,803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6480934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6,398,540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3196565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5,416,387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2836996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,022,838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55792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8,199,456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9916980"/>
                  </a:ext>
                </a:extLst>
              </a:tr>
              <a:tr h="187601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8,856,787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2196988"/>
                  </a:ext>
                </a:extLst>
              </a:tr>
              <a:tr h="153929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7,230,095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7897816"/>
                  </a:ext>
                </a:extLst>
              </a:tr>
              <a:tr h="153929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ck re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7,440,018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3488288"/>
                  </a:ext>
                </a:extLst>
              </a:tr>
              <a:tr h="153929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7,545,855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0270686"/>
                  </a:ext>
                </a:extLst>
              </a:tr>
              <a:tr h="153929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7,609,906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1044645"/>
                  </a:ext>
                </a:extLst>
              </a:tr>
              <a:tr h="153929"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re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-seq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3,594,923</a:t>
                      </a:r>
                      <a:endParaRPr lang="en-AU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03391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4714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8F2DA8-9C94-4025-A97B-BFFA128AD58F}"/>
              </a:ext>
            </a:extLst>
          </p:cNvPr>
          <p:cNvSpPr txBox="1"/>
          <p:nvPr/>
        </p:nvSpPr>
        <p:spPr>
          <a:xfrm>
            <a:off x="83158" y="8560061"/>
            <a:ext cx="66916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etagene coverage aligned to the start codon of all annotated protein coding genes.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156CA433-27EA-4A65-A16F-AE7227BB3D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58" y="6761737"/>
            <a:ext cx="3236983" cy="1798324"/>
          </a:xfrm>
          <a:prstGeom prst="rect">
            <a:avLst/>
          </a:prstGeom>
        </p:spPr>
      </p:pic>
      <p:pic>
        <p:nvPicPr>
          <p:cNvPr id="6" name="Picture 5" descr="Chart&#10;&#10;Description automatically generated with medium confidence">
            <a:extLst>
              <a:ext uri="{FF2B5EF4-FFF2-40B4-BE49-F238E27FC236}">
                <a16:creationId xmlns:a16="http://schemas.microsoft.com/office/drawing/2014/main" id="{1F706E25-1D7E-4B69-88F7-F217C30BC6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7859" y="6761737"/>
            <a:ext cx="3236983" cy="179832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746A199-474B-460F-B1B0-D396A4740A55}"/>
              </a:ext>
            </a:extLst>
          </p:cNvPr>
          <p:cNvSpPr txBox="1"/>
          <p:nvPr/>
        </p:nvSpPr>
        <p:spPr>
          <a:xfrm>
            <a:off x="879323" y="5089797"/>
            <a:ext cx="459014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AU" sz="1100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ad coverage mature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RNAs in a representative sample (SARS-CoV-2 24h rep1). Blue dashed lines represent the position of the anti-codon loop in the tRNA.   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527C90A-0673-46E7-B589-28F72D2CCFD8}"/>
              </a:ext>
            </a:extLst>
          </p:cNvPr>
          <p:cNvGrpSpPr/>
          <p:nvPr/>
        </p:nvGrpSpPr>
        <p:grpSpPr>
          <a:xfrm>
            <a:off x="812800" y="568595"/>
            <a:ext cx="4461933" cy="4521202"/>
            <a:chOff x="812800" y="568595"/>
            <a:chExt cx="4461933" cy="4521202"/>
          </a:xfrm>
        </p:grpSpPr>
        <p:pic>
          <p:nvPicPr>
            <p:cNvPr id="9" name="Picture 8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57D96330-D95F-4BFE-91F3-C0F9E6C92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2800" y="627864"/>
              <a:ext cx="4461933" cy="4461933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8EC30F2-279C-49D4-9BB9-B436A16F00C2}"/>
                </a:ext>
              </a:extLst>
            </p:cNvPr>
            <p:cNvSpPr txBox="1"/>
            <p:nvPr/>
          </p:nvSpPr>
          <p:spPr>
            <a:xfrm>
              <a:off x="1197882" y="568595"/>
              <a:ext cx="13462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84346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25</TotalTime>
  <Words>135</Words>
  <Application>Microsoft Office PowerPoint</Application>
  <PresentationFormat>A4 Paper (210x297 mm)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na Alexander</dc:creator>
  <cp:lastModifiedBy>Marina Alexander</cp:lastModifiedBy>
  <cp:revision>2</cp:revision>
  <dcterms:created xsi:type="dcterms:W3CDTF">2021-03-18T23:21:10Z</dcterms:created>
  <dcterms:modified xsi:type="dcterms:W3CDTF">2021-03-23T10:27:02Z</dcterms:modified>
</cp:coreProperties>
</file>